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  <p:sldId id="421" r:id="rId3"/>
    <p:sldId id="267" r:id="rId4"/>
    <p:sldId id="42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160" userDrawn="1">
          <p15:clr>
            <a:srgbClr val="A4A3A4"/>
          </p15:clr>
        </p15:guide>
        <p15:guide id="2" orient="horz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80"/>
    <a:srgbClr val="FFFFFF"/>
    <a:srgbClr val="C55A11"/>
    <a:srgbClr val="009900"/>
    <a:srgbClr val="33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72" autoAdjust="0"/>
    <p:restoredTop sz="94660"/>
  </p:normalViewPr>
  <p:slideViewPr>
    <p:cSldViewPr snapToGrid="0">
      <p:cViewPr>
        <p:scale>
          <a:sx n="125" d="100"/>
          <a:sy n="125" d="100"/>
        </p:scale>
        <p:origin x="2364" y="-1422"/>
      </p:cViewPr>
      <p:guideLst>
        <p:guide pos="2160"/>
        <p:guide orient="horz"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215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4656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779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297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8018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07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407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7604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715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8049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478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6C9FF-221B-4B26-B077-D421105A9B01}" type="datetimeFigureOut">
              <a:rPr lang="zh-CN" altLang="en-US" smtClean="0"/>
              <a:t>2025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37C15-8D9C-4774-A848-4DBAD0E19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0381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7" Type="http://schemas.openxmlformats.org/officeDocument/2006/relationships/image" Target="../media/image8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sv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"/><Relationship Id="rId13" Type="http://schemas.openxmlformats.org/officeDocument/2006/relationships/image" Target="../media/image20.tif"/><Relationship Id="rId3" Type="http://schemas.openxmlformats.org/officeDocument/2006/relationships/image" Target="../media/image10.tif"/><Relationship Id="rId7" Type="http://schemas.openxmlformats.org/officeDocument/2006/relationships/image" Target="../media/image14.tif"/><Relationship Id="rId12" Type="http://schemas.openxmlformats.org/officeDocument/2006/relationships/image" Target="../media/image19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"/><Relationship Id="rId11" Type="http://schemas.openxmlformats.org/officeDocument/2006/relationships/image" Target="../media/image18.tif"/><Relationship Id="rId5" Type="http://schemas.openxmlformats.org/officeDocument/2006/relationships/image" Target="../media/image12.tif"/><Relationship Id="rId10" Type="http://schemas.openxmlformats.org/officeDocument/2006/relationships/image" Target="../media/image17.tif"/><Relationship Id="rId4" Type="http://schemas.openxmlformats.org/officeDocument/2006/relationships/image" Target="../media/image11.tif"/><Relationship Id="rId9" Type="http://schemas.openxmlformats.org/officeDocument/2006/relationships/image" Target="../media/image16.ti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E9E5834-CEE9-47FF-E115-F9615297AF07}"/>
              </a:ext>
            </a:extLst>
          </p:cNvPr>
          <p:cNvGrpSpPr/>
          <p:nvPr/>
        </p:nvGrpSpPr>
        <p:grpSpPr>
          <a:xfrm>
            <a:off x="2250293" y="1016258"/>
            <a:ext cx="2579990" cy="2819765"/>
            <a:chOff x="1486205" y="5688467"/>
            <a:chExt cx="2579990" cy="2819765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AD2BE46C-75E4-21ED-8E73-A2B520836F21}"/>
                </a:ext>
              </a:extLst>
            </p:cNvPr>
            <p:cNvGrpSpPr/>
            <p:nvPr/>
          </p:nvGrpSpPr>
          <p:grpSpPr>
            <a:xfrm>
              <a:off x="1553831" y="5933417"/>
              <a:ext cx="2444738" cy="2326898"/>
              <a:chOff x="723251" y="5819117"/>
              <a:chExt cx="2444738" cy="2326898"/>
            </a:xfrm>
          </p:grpSpPr>
          <p:pic>
            <p:nvPicPr>
              <p:cNvPr id="9" name="图形 8">
                <a:extLst>
                  <a:ext uri="{FF2B5EF4-FFF2-40B4-BE49-F238E27FC236}">
                    <a16:creationId xmlns:a16="http://schemas.microsoft.com/office/drawing/2014/main" id="{B871B308-7ED9-7340-3A25-ABB2952226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rcRect l="10373" t="13748" r="15493" b="7851"/>
              <a:stretch/>
            </p:blipFill>
            <p:spPr>
              <a:xfrm>
                <a:off x="723251" y="5819117"/>
                <a:ext cx="2444738" cy="2326898"/>
              </a:xfrm>
              <a:prstGeom prst="rect">
                <a:avLst/>
              </a:prstGeom>
            </p:spPr>
          </p:pic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75717843-A9E8-D140-F424-08A71A678E3D}"/>
                  </a:ext>
                </a:extLst>
              </p:cNvPr>
              <p:cNvSpPr txBox="1"/>
              <p:nvPr/>
            </p:nvSpPr>
            <p:spPr>
              <a:xfrm>
                <a:off x="1757449" y="6784446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BDBB5E34-8D22-FB3F-7EB7-8238BAB681A4}"/>
                  </a:ext>
                </a:extLst>
              </p:cNvPr>
              <p:cNvSpPr txBox="1"/>
              <p:nvPr/>
            </p:nvSpPr>
            <p:spPr>
              <a:xfrm>
                <a:off x="2274684" y="6982566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A66DD9D3-7920-D8E6-E16E-12A85D458C1A}"/>
                  </a:ext>
                </a:extLst>
              </p:cNvPr>
              <p:cNvSpPr txBox="1"/>
              <p:nvPr/>
            </p:nvSpPr>
            <p:spPr>
              <a:xfrm>
                <a:off x="1767663" y="7473589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C1EB24FB-5B5C-4D0E-95C3-3C1727EBAD34}"/>
                  </a:ext>
                </a:extLst>
              </p:cNvPr>
              <p:cNvSpPr txBox="1"/>
              <p:nvPr/>
            </p:nvSpPr>
            <p:spPr>
              <a:xfrm>
                <a:off x="2598420" y="6476182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4E5E830B-2576-C523-B90D-0F7B340AC10C}"/>
                  </a:ext>
                </a:extLst>
              </p:cNvPr>
              <p:cNvSpPr txBox="1"/>
              <p:nvPr/>
            </p:nvSpPr>
            <p:spPr>
              <a:xfrm>
                <a:off x="952907" y="6476183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4A0D437C-8B37-31AB-5923-1F3712B09EA8}"/>
                  </a:ext>
                </a:extLst>
              </p:cNvPr>
              <p:cNvSpPr txBox="1"/>
              <p:nvPr/>
            </p:nvSpPr>
            <p:spPr>
              <a:xfrm>
                <a:off x="1310624" y="6956046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811A624F-B5D1-2923-2454-A804E39B51CD}"/>
                  </a:ext>
                </a:extLst>
              </p:cNvPr>
              <p:cNvSpPr txBox="1"/>
              <p:nvPr/>
            </p:nvSpPr>
            <p:spPr>
              <a:xfrm>
                <a:off x="1809134" y="6171880"/>
                <a:ext cx="3763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A75FB84-FBDA-269A-6855-FC38DC15C019}"/>
                </a:ext>
              </a:extLst>
            </p:cNvPr>
            <p:cNvSpPr txBox="1"/>
            <p:nvPr/>
          </p:nvSpPr>
          <p:spPr>
            <a:xfrm>
              <a:off x="1486205" y="5703320"/>
              <a:ext cx="115350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GO:0009908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6D93101-4A65-2066-5F56-3F7EAC0709E1}"/>
                </a:ext>
              </a:extLst>
            </p:cNvPr>
            <p:cNvSpPr txBox="1"/>
            <p:nvPr/>
          </p:nvSpPr>
          <p:spPr>
            <a:xfrm>
              <a:off x="2860192" y="5688467"/>
              <a:ext cx="120600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GO:0090567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F8255AE-EC7A-6B3B-1248-196FB90EF8F9}"/>
                </a:ext>
              </a:extLst>
            </p:cNvPr>
            <p:cNvSpPr txBox="1"/>
            <p:nvPr/>
          </p:nvSpPr>
          <p:spPr>
            <a:xfrm>
              <a:off x="2261559" y="8200455"/>
              <a:ext cx="119726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</a:lstStyle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O:0048367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003007B2-BD3D-ABF0-CC74-28F15CED0016}"/>
              </a:ext>
            </a:extLst>
          </p:cNvPr>
          <p:cNvSpPr txBox="1"/>
          <p:nvPr/>
        </p:nvSpPr>
        <p:spPr>
          <a:xfrm>
            <a:off x="599776" y="4045789"/>
            <a:ext cx="59014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600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1.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Venn diagram showing the DEGs number in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lower development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O:0009908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,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eproductive shoot system development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(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O:0090567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 and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hoot system development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O:0048367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</a:t>
            </a:r>
            <a:endParaRPr lang="en-US" altLang="zh-CN" sz="1600" kern="100" dirty="0">
              <a:effectLst/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9026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形 2">
            <a:extLst>
              <a:ext uri="{FF2B5EF4-FFF2-40B4-BE49-F238E27FC236}">
                <a16:creationId xmlns:a16="http://schemas.microsoft.com/office/drawing/2014/main" id="{AF9C1BF0-3D55-468B-B35C-311272D208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23394" t="11789" r="5491" b="13349"/>
          <a:stretch/>
        </p:blipFill>
        <p:spPr>
          <a:xfrm>
            <a:off x="140296" y="283685"/>
            <a:ext cx="3180679" cy="1821109"/>
          </a:xfrm>
          <a:prstGeom prst="rect">
            <a:avLst/>
          </a:prstGeom>
        </p:spPr>
      </p:pic>
      <p:grpSp>
        <p:nvGrpSpPr>
          <p:cNvPr id="23" name="组合 22">
            <a:extLst>
              <a:ext uri="{FF2B5EF4-FFF2-40B4-BE49-F238E27FC236}">
                <a16:creationId xmlns:a16="http://schemas.microsoft.com/office/drawing/2014/main" id="{072DE27D-C29F-4BB2-A786-630D4C2D9498}"/>
              </a:ext>
            </a:extLst>
          </p:cNvPr>
          <p:cNvGrpSpPr/>
          <p:nvPr/>
        </p:nvGrpSpPr>
        <p:grpSpPr>
          <a:xfrm>
            <a:off x="-20009" y="283685"/>
            <a:ext cx="6671676" cy="4051504"/>
            <a:chOff x="-20009" y="283685"/>
            <a:chExt cx="6671676" cy="4051504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C0C32B1A-22F0-4B7F-A6FA-96E06410641C}"/>
                </a:ext>
              </a:extLst>
            </p:cNvPr>
            <p:cNvGrpSpPr/>
            <p:nvPr/>
          </p:nvGrpSpPr>
          <p:grpSpPr>
            <a:xfrm>
              <a:off x="53919" y="388045"/>
              <a:ext cx="6597748" cy="3947144"/>
              <a:chOff x="53919" y="388045"/>
              <a:chExt cx="6597748" cy="3947144"/>
            </a:xfrm>
          </p:grpSpPr>
          <p:pic>
            <p:nvPicPr>
              <p:cNvPr id="5" name="图形 4">
                <a:extLst>
                  <a:ext uri="{FF2B5EF4-FFF2-40B4-BE49-F238E27FC236}">
                    <a16:creationId xmlns:a16="http://schemas.microsoft.com/office/drawing/2014/main" id="{F73D4732-D4F9-47D1-A7EF-134AB877E5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rcRect l="27611" t="16648" r="6222" b="16633"/>
              <a:stretch/>
            </p:blipFill>
            <p:spPr>
              <a:xfrm>
                <a:off x="3674340" y="388045"/>
                <a:ext cx="2977327" cy="1632899"/>
              </a:xfrm>
              <a:prstGeom prst="rect">
                <a:avLst/>
              </a:prstGeom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34C5BA19-4C15-4868-8DBD-854624E0202E}"/>
                  </a:ext>
                </a:extLst>
              </p:cNvPr>
              <p:cNvSpPr txBox="1"/>
              <p:nvPr/>
            </p:nvSpPr>
            <p:spPr>
              <a:xfrm>
                <a:off x="1548291" y="1743191"/>
                <a:ext cx="106107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kern="1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urquoise</a:t>
                </a:r>
                <a:endParaRPr lang="zh-CN" altLang="en-US" dirty="0"/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E42A4EE2-8D90-41E4-B814-B127A639B9BA}"/>
                  </a:ext>
                </a:extLst>
              </p:cNvPr>
              <p:cNvSpPr txBox="1"/>
              <p:nvPr/>
            </p:nvSpPr>
            <p:spPr>
              <a:xfrm>
                <a:off x="5124903" y="1755974"/>
                <a:ext cx="106107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kern="1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brown</a:t>
                </a:r>
                <a:endParaRPr lang="zh-CN" altLang="en-US" dirty="0"/>
              </a:p>
            </p:txBody>
          </p:sp>
          <p:pic>
            <p:nvPicPr>
              <p:cNvPr id="8" name="图形 7">
                <a:extLst>
                  <a:ext uri="{FF2B5EF4-FFF2-40B4-BE49-F238E27FC236}">
                    <a16:creationId xmlns:a16="http://schemas.microsoft.com/office/drawing/2014/main" id="{7256FBB1-C03A-4455-A7A5-386B8AABFF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rcRect l="25111" t="13396" r="7112" b="13637"/>
              <a:stretch/>
            </p:blipFill>
            <p:spPr>
              <a:xfrm>
                <a:off x="53919" y="2585145"/>
                <a:ext cx="2988743" cy="1750044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D769A8B7-DED0-4E0E-B6F1-0633EB78355B}"/>
                  </a:ext>
                </a:extLst>
              </p:cNvPr>
              <p:cNvSpPr txBox="1"/>
              <p:nvPr/>
            </p:nvSpPr>
            <p:spPr>
              <a:xfrm>
                <a:off x="1548290" y="3965857"/>
                <a:ext cx="75438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kern="1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reen</a:t>
                </a:r>
                <a:endParaRPr lang="zh-CN" altLang="en-US" dirty="0"/>
              </a:p>
            </p:txBody>
          </p:sp>
        </p:grp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42867C2-6E3E-4BA5-B75E-47EC8E1FF8EC}"/>
                </a:ext>
              </a:extLst>
            </p:cNvPr>
            <p:cNvSpPr txBox="1"/>
            <p:nvPr/>
          </p:nvSpPr>
          <p:spPr>
            <a:xfrm>
              <a:off x="-20009" y="28368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E20BA2EF-60BD-46A0-AED3-DDF6CF9D20F1}"/>
                </a:ext>
              </a:extLst>
            </p:cNvPr>
            <p:cNvSpPr txBox="1"/>
            <p:nvPr/>
          </p:nvSpPr>
          <p:spPr>
            <a:xfrm>
              <a:off x="3512198" y="283685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8">
              <a:extLst>
                <a:ext uri="{FF2B5EF4-FFF2-40B4-BE49-F238E27FC236}">
                  <a16:creationId xmlns:a16="http://schemas.microsoft.com/office/drawing/2014/main" id="{044C531D-871F-48F3-A299-BACD74F867B7}"/>
                </a:ext>
              </a:extLst>
            </p:cNvPr>
            <p:cNvSpPr txBox="1"/>
            <p:nvPr/>
          </p:nvSpPr>
          <p:spPr>
            <a:xfrm>
              <a:off x="0" y="2400479"/>
              <a:ext cx="2872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3E4347FE-9FB3-B949-61F3-2DBBF57CA8CF}"/>
              </a:ext>
            </a:extLst>
          </p:cNvPr>
          <p:cNvSpPr txBox="1"/>
          <p:nvPr/>
        </p:nvSpPr>
        <p:spPr>
          <a:xfrm>
            <a:off x="518936" y="4616906"/>
            <a:ext cx="598652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2. 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-expression network analysis of DEGs in turquoise</a:t>
            </a:r>
            <a:r>
              <a:rPr lang="en-US" altLang="zh-CN" sz="1100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own and green</a:t>
            </a:r>
            <a:r>
              <a:rPr lang="zh-CN" altLang="en-US" sz="1100" kern="100" dirty="0"/>
              <a:t>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dule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175579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2C18C43-0553-8951-F449-8146B332CC65}"/>
              </a:ext>
            </a:extLst>
          </p:cNvPr>
          <p:cNvGrpSpPr/>
          <p:nvPr/>
        </p:nvGrpSpPr>
        <p:grpSpPr>
          <a:xfrm>
            <a:off x="534449" y="619617"/>
            <a:ext cx="5584766" cy="5766846"/>
            <a:chOff x="534449" y="619617"/>
            <a:chExt cx="5584766" cy="5766846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67CBA35C-5601-DBDC-A114-1235D7427C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58" t="8081" r="3096" b="7670"/>
            <a:stretch/>
          </p:blipFill>
          <p:spPr>
            <a:xfrm>
              <a:off x="558968" y="3635442"/>
              <a:ext cx="1785103" cy="1273848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C2760B37-2DE8-F6ED-B915-B39D01FE41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8" t="8796" r="3835" b="6956"/>
            <a:stretch/>
          </p:blipFill>
          <p:spPr>
            <a:xfrm>
              <a:off x="2432143" y="5112615"/>
              <a:ext cx="1809624" cy="1273848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224DA8A-514E-0295-9A45-3DBAE1277E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9" t="8052" r="2934" b="7698"/>
            <a:stretch/>
          </p:blipFill>
          <p:spPr>
            <a:xfrm>
              <a:off x="4309593" y="5094835"/>
              <a:ext cx="1809622" cy="1273848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DA6076A-0158-3797-3FCF-08184BEB53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06" r="4722"/>
            <a:stretch/>
          </p:blipFill>
          <p:spPr>
            <a:xfrm>
              <a:off x="554355" y="619617"/>
              <a:ext cx="1769811" cy="1512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C0082EF9-1E77-D6E0-F086-CFF33BA56F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04" r="1324"/>
            <a:stretch/>
          </p:blipFill>
          <p:spPr>
            <a:xfrm>
              <a:off x="2491743" y="627573"/>
              <a:ext cx="1769811" cy="151200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CABE0AB6-8805-245C-DAE5-CD5E256173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92" r="4021"/>
            <a:stretch/>
          </p:blipFill>
          <p:spPr>
            <a:xfrm>
              <a:off x="4295411" y="627573"/>
              <a:ext cx="1809622" cy="1512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DFEE69B-E299-B980-07A4-A9DA916FBA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2" t="8253" r="3425" b="8718"/>
            <a:stretch/>
          </p:blipFill>
          <p:spPr>
            <a:xfrm>
              <a:off x="2452050" y="2150070"/>
              <a:ext cx="1769811" cy="1255395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8AAB2FF6-3328-5DDD-DED1-32FBFF9DE1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73" t="7271" r="3641" b="8479"/>
            <a:stretch/>
          </p:blipFill>
          <p:spPr>
            <a:xfrm>
              <a:off x="534449" y="2131618"/>
              <a:ext cx="1809622" cy="1273848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612F43E8-C0B2-D765-AB5F-36A9FF9C6E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17" t="7783" r="3711" b="7968"/>
            <a:stretch/>
          </p:blipFill>
          <p:spPr>
            <a:xfrm>
              <a:off x="4324885" y="2150070"/>
              <a:ext cx="1769811" cy="1273848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4DA06DC0-52B9-609F-DC92-A64D946EA9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3" t="8185" r="4242" b="7566"/>
            <a:stretch/>
          </p:blipFill>
          <p:spPr>
            <a:xfrm>
              <a:off x="4309593" y="3635442"/>
              <a:ext cx="1785103" cy="1273848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01FC907-1D36-CF68-9ADE-F9CAB560AA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6" t="7875" r="4277" b="7875"/>
            <a:stretch/>
          </p:blipFill>
          <p:spPr>
            <a:xfrm>
              <a:off x="2402669" y="3635442"/>
              <a:ext cx="1809623" cy="1273848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62022526-7473-A26B-666A-03165D78C4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4" t="11121" r="2110" b="8580"/>
            <a:stretch/>
          </p:blipFill>
          <p:spPr>
            <a:xfrm>
              <a:off x="546708" y="5142479"/>
              <a:ext cx="1809622" cy="1214120"/>
            </a:xfrm>
            <a:prstGeom prst="rect">
              <a:avLst/>
            </a:prstGeom>
          </p:spPr>
        </p:pic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ADEAB44F-B8E1-8317-FD9B-E7F6A8A9AF4D}"/>
              </a:ext>
            </a:extLst>
          </p:cNvPr>
          <p:cNvSpPr txBox="1"/>
          <p:nvPr/>
        </p:nvSpPr>
        <p:spPr>
          <a:xfrm>
            <a:off x="1628415" y="6515498"/>
            <a:ext cx="412203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latinLnBrk="1"/>
            <a:r>
              <a:rPr lang="en-US" altLang="zh-CN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3. </a:t>
            </a:r>
            <a:r>
              <a:rPr lang="en-US" altLang="zh-CN" sz="11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The </a:t>
            </a:r>
            <a:r>
              <a:rPr lang="en-US" altLang="zh-CN" sz="11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qRT</a:t>
            </a:r>
            <a:r>
              <a:rPr lang="en-US" altLang="zh-CN" sz="11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-PCR validation for transcriptome data</a:t>
            </a:r>
            <a:endParaRPr lang="en-US" altLang="zh-CN" sz="1100" kern="100" dirty="0">
              <a:effectLst/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78921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1D18C5A-A7AB-7A91-17A4-DE52C1DE26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6522" y="1078497"/>
            <a:ext cx="4873083" cy="365997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B85B58E-5C19-20DB-2521-94D69A3FF541}"/>
              </a:ext>
            </a:extLst>
          </p:cNvPr>
          <p:cNvSpPr txBox="1"/>
          <p:nvPr/>
        </p:nvSpPr>
        <p:spPr>
          <a:xfrm>
            <a:off x="1801123" y="4822195"/>
            <a:ext cx="31611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4.   </a:t>
            </a:r>
            <a:r>
              <a:rPr lang="en-US" altLang="zh-CN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BUSCO assessment results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571544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81</TotalTime>
  <Words>88</Words>
  <Application>Microsoft Office PowerPoint</Application>
  <PresentationFormat>A4 Paper (210x297 mm)</PresentationFormat>
  <Paragraphs>2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ohongyan</dc:creator>
  <cp:lastModifiedBy>MDPI</cp:lastModifiedBy>
  <cp:revision>67</cp:revision>
  <dcterms:created xsi:type="dcterms:W3CDTF">2022-09-26T07:54:36Z</dcterms:created>
  <dcterms:modified xsi:type="dcterms:W3CDTF">2025-07-30T06:40:36Z</dcterms:modified>
</cp:coreProperties>
</file>